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wmf" ContentType="image/x-wmf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0A10B62-F82B-4A44-B3B6-27DD1E61B390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E22398A-474D-40E1-9280-9F6D2B95D4E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71B2694-552C-4193-ADAC-9E9FC4EACAF5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7558A55-5848-4669-B426-96220131CCAE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641BD2A-D46A-44FC-ABED-33A57FFD956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6ADDDEA-17B1-4A85-932E-0C59914E85D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B1061BC-F832-4455-9F98-E363CAA45F7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C20B2C5-1A2A-4D0C-B791-DD8E8130FFA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67E19D5-7D61-4FFD-AC7E-59BDC3BC1E7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B8987E8-1DEB-46BA-A0B5-180DD41CC6D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5D7E6D3-7E2D-4FE1-96D6-A52409A2F35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62B383A-669A-4B6C-A1C7-15FDE51F3F2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pl-PL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5526C7D-53B4-46D4-96A7-B73431D475B6}" type="slidenum">
              <a:rPr b="0" lang="pl-PL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image" Target="../media/image1.wmf"/><Relationship Id="rId3" Type="http://schemas.openxmlformats.org/officeDocument/2006/relationships/image" Target="../media/image1.wmf"/><Relationship Id="rId4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Picture 6" descr=""/>
          <p:cNvPicPr/>
          <p:nvPr/>
        </p:nvPicPr>
        <p:blipFill>
          <a:blip r:embed="rId1"/>
          <a:srcRect l="-1463" t="34007" r="1009" b="36449"/>
          <a:stretch/>
        </p:blipFill>
        <p:spPr>
          <a:xfrm>
            <a:off x="762120" y="3665520"/>
            <a:ext cx="4895640" cy="1440000"/>
          </a:xfrm>
          <a:prstGeom prst="rect">
            <a:avLst/>
          </a:prstGeom>
          <a:ln w="0">
            <a:noFill/>
          </a:ln>
        </p:spPr>
      </p:pic>
      <p:pic>
        <p:nvPicPr>
          <p:cNvPr id="42" name="Picture 5" descr=""/>
          <p:cNvPicPr/>
          <p:nvPr/>
        </p:nvPicPr>
        <p:blipFill>
          <a:blip r:embed="rId2"/>
          <a:srcRect l="-1494" t="69447" r="0" b="6905"/>
          <a:stretch/>
        </p:blipFill>
        <p:spPr>
          <a:xfrm>
            <a:off x="762120" y="1631880"/>
            <a:ext cx="4946400" cy="1187640"/>
          </a:xfrm>
          <a:prstGeom prst="rect">
            <a:avLst/>
          </a:prstGeom>
          <a:ln w="0">
            <a:noFill/>
          </a:ln>
        </p:spPr>
      </p:pic>
      <p:sp>
        <p:nvSpPr>
          <p:cNvPr id="43" name="Text Box 7"/>
          <p:cNvSpPr/>
          <p:nvPr/>
        </p:nvSpPr>
        <p:spPr>
          <a:xfrm>
            <a:off x="2286000" y="2786040"/>
            <a:ext cx="21542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pl-PL" sz="1600" spc="-1" strike="noStrike">
                <a:solidFill>
                  <a:srgbClr val="000000"/>
                </a:solidFill>
                <a:latin typeface="Arial"/>
              </a:rPr>
              <a:t>Control HeLa cells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Text Box 10"/>
          <p:cNvSpPr/>
          <p:nvPr/>
        </p:nvSpPr>
        <p:spPr>
          <a:xfrm>
            <a:off x="833400" y="5029200"/>
            <a:ext cx="49546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pl-PL" sz="1600" spc="-1" strike="noStrike">
                <a:solidFill>
                  <a:srgbClr val="000000"/>
                </a:solidFill>
                <a:latin typeface="Arial"/>
              </a:rPr>
              <a:t>            </a:t>
            </a:r>
            <a:r>
              <a:rPr b="1" lang="pl-PL" sz="1600" spc="-1" strike="noStrike">
                <a:solidFill>
                  <a:srgbClr val="000000"/>
                </a:solidFill>
                <a:latin typeface="Arial"/>
              </a:rPr>
              <a:t>HAWW</a:t>
            </a:r>
            <a:r>
              <a:rPr b="1" lang="pl-PL" sz="16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1" lang="pl-PL" sz="16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1" lang="pl-PL" sz="1600" spc="-1" strike="noStrike">
                <a:solidFill>
                  <a:srgbClr val="000000"/>
                </a:solidFill>
                <a:latin typeface="Arial"/>
              </a:rPr>
              <a:t>             Dd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5" name="Picture 12" descr=""/>
          <p:cNvPicPr/>
          <p:nvPr/>
        </p:nvPicPr>
        <p:blipFill>
          <a:blip r:embed="rId3"/>
          <a:srcRect l="0" t="4723" r="-451" b="68698"/>
          <a:stretch/>
        </p:blipFill>
        <p:spPr>
          <a:xfrm>
            <a:off x="819000" y="5557680"/>
            <a:ext cx="4896000" cy="1295640"/>
          </a:xfrm>
          <a:prstGeom prst="rect">
            <a:avLst/>
          </a:prstGeom>
          <a:ln w="0">
            <a:noFill/>
          </a:ln>
        </p:spPr>
      </p:pic>
      <p:sp>
        <p:nvSpPr>
          <p:cNvPr id="46" name="Text Box 13"/>
          <p:cNvSpPr/>
          <p:nvPr/>
        </p:nvSpPr>
        <p:spPr>
          <a:xfrm>
            <a:off x="2124000" y="6781680"/>
            <a:ext cx="24480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pl-PL" sz="1600" spc="-1" strike="noStrike">
                <a:solidFill>
                  <a:srgbClr val="000000"/>
                </a:solidFill>
                <a:latin typeface="Arial"/>
              </a:rPr>
              <a:t>Complex Dd-HAWW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Text Box 16"/>
          <p:cNvSpPr/>
          <p:nvPr/>
        </p:nvSpPr>
        <p:spPr>
          <a:xfrm>
            <a:off x="1139760" y="1066680"/>
            <a:ext cx="4346640" cy="1015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5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pl-PL" sz="2400" spc="-1" strike="noStrike">
                <a:solidFill>
                  <a:srgbClr val="000000"/>
                </a:solidFill>
                <a:latin typeface="Arial"/>
              </a:rPr>
              <a:t>Anti-HA Ab</a:t>
            </a:r>
            <a:r>
              <a:rPr b="1" lang="pl-PL" sz="18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1" lang="pl-PL" sz="2400" spc="-1" strike="noStrike">
                <a:solidFill>
                  <a:srgbClr val="000000"/>
                </a:solidFill>
                <a:latin typeface="Arial"/>
              </a:rPr>
              <a:t>        Anti-Dd Ab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15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Text Box 20"/>
          <p:cNvSpPr/>
          <p:nvPr/>
        </p:nvSpPr>
        <p:spPr>
          <a:xfrm>
            <a:off x="380880" y="8001000"/>
            <a:ext cx="502920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25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"/>
              </a:rPr>
              <a:t>Naskalska et al, Fig. 5, Suppl. data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99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04-06T09:27:42Z</dcterms:created>
  <dc:creator>Ewa Szołajska</dc:creator>
  <dc:description/>
  <dc:language>en-US</dc:language>
  <cp:lastModifiedBy>mm</cp:lastModifiedBy>
  <dcterms:modified xsi:type="dcterms:W3CDTF">2012-11-21T08:41:25Z</dcterms:modified>
  <cp:revision>24</cp:revision>
  <dc:subject/>
  <dc:title>Slajd 1</dc:title>
</cp:coreProperties>
</file>